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handoutMasterIdLst>
    <p:handoutMasterId r:id="rId4"/>
  </p:handoutMasterIdLst>
  <p:sldIdLst>
    <p:sldId id="270" r:id="rId2"/>
    <p:sldId id="272" r:id="rId3"/>
  </p:sldIdLst>
  <p:sldSz cx="6858000" cy="9144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>
      <p:cViewPr>
        <p:scale>
          <a:sx n="139" d="100"/>
          <a:sy n="139" d="100"/>
        </p:scale>
        <p:origin x="1872" y="-3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F5B47A-B87A-466F-8F04-01D1821A4D7E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3F5AD6-7456-4DED-A27A-08804B5DA6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5433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141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15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4365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849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64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99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921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6232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1297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012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95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E3EF7-B030-420A-B6B0-E5F961C064A4}" type="datetimeFigureOut">
              <a:rPr lang="en-GB" smtClean="0"/>
              <a:t>30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48D53-F07C-45E0-BB81-0D5BD007D5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348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584724" y="4227693"/>
            <a:ext cx="5997515" cy="4472182"/>
            <a:chOff x="429448" y="2743950"/>
            <a:chExt cx="5997515" cy="4472182"/>
          </a:xfrm>
        </p:grpSpPr>
        <p:sp>
          <p:nvSpPr>
            <p:cNvPr id="7" name="Rectangle 6"/>
            <p:cNvSpPr/>
            <p:nvPr/>
          </p:nvSpPr>
          <p:spPr>
            <a:xfrm>
              <a:off x="429448" y="6385135"/>
              <a:ext cx="5997515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1200" b="1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upplementary figure 1.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b="1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rrelation between telomere length (T/S ratio) and age.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 scatterplot showing a significant negative correlation between age (x-axis) and adjusted relative telomere length (y-axis). n=90, r=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0.7039, ****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&lt;0.001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. The Spearman correlation coefficient ( r ) is indicated. 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aphicFrame>
          <p:nvGraphicFramePr>
            <p:cNvPr id="8" name="Object 7"/>
            <p:cNvGraphicFramePr>
              <a:graphicFrameLocks noChangeAspect="1"/>
            </p:cNvGraphicFramePr>
            <p:nvPr/>
          </p:nvGraphicFramePr>
          <p:xfrm>
            <a:off x="1576927" y="2743950"/>
            <a:ext cx="3705225" cy="3659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704716" imgH="3659165" progId="Prism8.Document">
                    <p:embed/>
                  </p:oleObj>
                </mc:Choice>
                <mc:Fallback>
                  <p:oleObj name="Prism 8" r:id="rId2" imgW="3704716" imgH="3659165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576927" y="2743950"/>
                          <a:ext cx="3705225" cy="36591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TextBox 9"/>
          <p:cNvSpPr txBox="1"/>
          <p:nvPr/>
        </p:nvSpPr>
        <p:spPr>
          <a:xfrm>
            <a:off x="241540" y="3381555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137372"/>
            <a:ext cx="6858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Material</a:t>
            </a:r>
          </a:p>
          <a:p>
            <a:pPr algn="just">
              <a:spcAft>
                <a:spcPts val="0"/>
              </a:spcAft>
            </a:pPr>
            <a:endParaRPr lang="en-US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itle: Relationship between aging and control of metabolic syndrome with telomere shortening- A cross-sectional study</a:t>
            </a:r>
            <a:endParaRPr lang="en-GB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Tarachand Devrajani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, 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hariq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bid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Hina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haikh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ram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haikh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urshana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i Devrajani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kander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unir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emon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Ali Muhammad Waryah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kram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in Ujjan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inafsha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anzoor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yed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GB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4635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7375031"/>
              </p:ext>
            </p:extLst>
          </p:nvPr>
        </p:nvGraphicFramePr>
        <p:xfrm>
          <a:off x="1735138" y="996950"/>
          <a:ext cx="3248025" cy="3876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247344" imgH="3877058" progId="Prism8.Document">
                  <p:embed/>
                </p:oleObj>
              </mc:Choice>
              <mc:Fallback>
                <p:oleObj name="Prism 8" r:id="rId2" imgW="3247344" imgH="38770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35138" y="996950"/>
                        <a:ext cx="3248025" cy="3876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0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43185" y="4868144"/>
            <a:ext cx="60320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gure 2.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lomere length (T/S ratio) and increasing age.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 box-plot showing a decrease in RTL, with increasing age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Kruskal-Wallis test was significant ***p&lt;0.001, post hoc Dunn’s test was applied for multiple comparison as displayed in box plots showing significant differences, ***p&lt;0.001.</a:t>
            </a:r>
            <a:endParaRPr lang="en-GB" sz="1200" i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485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0</TotalTime>
  <Words>177</Words>
  <Application>Microsoft Macintosh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Tarachand Devrajani</cp:lastModifiedBy>
  <cp:revision>63</cp:revision>
  <cp:lastPrinted>2023-09-26T09:00:03Z</cp:lastPrinted>
  <dcterms:created xsi:type="dcterms:W3CDTF">2023-05-02T09:28:04Z</dcterms:created>
  <dcterms:modified xsi:type="dcterms:W3CDTF">2023-09-30T08:46:57Z</dcterms:modified>
</cp:coreProperties>
</file>